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EEB8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83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5D007-34E2-7264-969A-36BF63CBAC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E333489-B5F6-87AA-2C10-EDF413BC57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4391A5-BBAE-FCCB-5E73-3E9A64261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811CC0-EA17-962C-9238-96A5EF7C1C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E7AC52-01A6-8987-5F5C-BA21336FA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595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BFEB75-EDC1-F691-A676-011C35047A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537949-166E-878A-BA93-96550F6BC7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D4B3C0-5C3C-C3CC-AD3B-B00D3D03D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CE9CEF-3EC0-05F7-57E1-F92B3A3AA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87A220-4721-8AE0-FB6A-2B38C0B79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02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E457479-B1E5-A6C3-F240-B7BAE2D180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7FB671-A008-EBE6-08C7-78F3F68C0A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161041-1392-6A10-487E-3CFAB27C8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5AE269-7AE5-1BE3-0006-C15697049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B6CBEA-5153-672D-9DF7-32BC33070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019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E1C328-6EA9-B7D1-E9CE-18129421FB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C30EDC-5F9A-7920-A98A-109B2EA45D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D26F2D-9531-AD4D-D13D-291323EF1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50CDD7-025A-ABE9-4421-3F870D0D8D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13FEC9-3ACC-C18D-2DB5-0FBF453EB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07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39FC71-39D9-817D-2D40-535388B525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1F8A70-3670-9DF4-4BB4-0CE2BFAAD4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20AF8D-8AA6-A04B-D6B0-F997EB4828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82DA14-7CA4-369F-3D66-692775AC9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F3112E-E32B-B111-3C40-B39C00ABE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113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EA6367-9F0D-EB08-2168-1D40F8AAA5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CBA125-7EEF-92E3-D774-71DB8D8E16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272FBC-59D6-CA8B-C85A-495D043883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E21250-746C-D43A-BA14-9E3A264863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D32804-94B4-C5AA-B26F-137683CBD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A92EBB-4B5B-B80F-1178-55852B653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576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BB358F-26C3-BB3C-D029-CB419CC9ED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A0F12E-37DC-E5FE-209B-917193412F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483BEB-60D5-7AB4-5397-0BD6B03E89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5EF861-698A-96BA-719C-D4C36A24B1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89B46F-605F-8152-BB11-5DE8DD046D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22A99F-EE82-46E2-67C8-35116B711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ADE6D3-3AD0-3DCB-8BCA-7582C512A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E93DB64-CA23-5866-A0E0-FBF1A05B6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900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DE057B-2C2C-087E-96B7-8FD4FB95E9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7FB38D6-5231-0720-5542-14AB27185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63F9BF-FCA4-4FC5-9E1F-0D4BEC54F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F2DF4A-92A7-54E3-0643-EEDB18E4D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695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0B01B8-50BE-0B19-CE45-AE465E7E5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DA12F1C-9841-3F2B-1725-FD9D63962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BFEE68A-2259-DEC5-1F16-0D3216D66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9065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9DAEBD-E9D1-F475-065E-1DD6840F3D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8E7D54-854B-12AB-89D8-3108FF990A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6BAFA6-A2B3-7C25-5673-31564633F9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E9ADB3-76F6-553A-AC44-6550A0910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4C3C07-DB19-533A-4FD9-22FA26820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A8C16D-1220-1297-63FB-D68AEF277C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565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A775F8-57E8-D94C-3787-88C2B76FD9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28448CA-3708-C3DE-BD32-C3D94DDA6A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77841F-A128-C1A8-7CE0-61CC27E038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1089D8-CFE8-9410-C254-7DFA77390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643864-08DB-BA16-6577-83C0EC3CE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F87674-36E6-CEBB-607E-0A8B24C101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360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49032E-F943-8CF9-5CCF-8969D110B3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E992BB-87CA-B5A4-8B19-7B2454AB86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618CFB-D0A1-D513-197B-BFEE28C4E5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7AC6BB-8B0C-492F-A550-EAC3A5EA27CF}" type="datetimeFigureOut">
              <a:rPr lang="en-US" smtClean="0"/>
              <a:t>1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5E1140-816D-0241-C098-663D75B8EB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01110B-274D-CD2F-3435-F2DB9A0668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EF0C8D-390A-40CA-A2AF-89BDC161A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3417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jpe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5" Type="http://schemas.openxmlformats.org/officeDocument/2006/relationships/image" Target="../media/image4.emf"/><Relationship Id="rId15" Type="http://schemas.openxmlformats.org/officeDocument/2006/relationships/image" Target="../media/image14.jpe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emf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5804E0D-B334-CC8B-DDBE-9F45F0865C1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28" name="TextBox 30">
            <a:extLst>
              <a:ext uri="{FF2B5EF4-FFF2-40B4-BE49-F238E27FC236}">
                <a16:creationId xmlns:a16="http://schemas.microsoft.com/office/drawing/2014/main" id="{2A280E4D-5FE5-8536-EAA6-8BD257E39F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89415" y="6421549"/>
            <a:ext cx="1784364" cy="307777"/>
          </a:xfrm>
          <a:prstGeom prst="rect">
            <a:avLst/>
          </a:prstGeom>
          <a:noFill/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/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algn="ctr" defTabSz="1448044" fontAlgn="base">
              <a:spcBef>
                <a:spcPct val="0"/>
              </a:spcBef>
              <a:spcAft>
                <a:spcPct val="0"/>
              </a:spcAft>
              <a:buNone/>
              <a:defRPr/>
            </a:pPr>
            <a:r>
              <a:rPr lang="en-US" alt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iked Rat plasm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AAE3D4C-CC1D-8E1B-8C9F-D76012B61D4C}"/>
              </a:ext>
            </a:extLst>
          </p:cNvPr>
          <p:cNvSpPr txBox="1"/>
          <p:nvPr/>
        </p:nvSpPr>
        <p:spPr>
          <a:xfrm>
            <a:off x="1656958" y="133239"/>
            <a:ext cx="2700185" cy="360420"/>
          </a:xfrm>
          <a:prstGeom prst="rect">
            <a:avLst/>
          </a:prstGeom>
          <a:solidFill>
            <a:srgbClr val="C00000"/>
          </a:solidFill>
          <a:scene3d>
            <a:camera prst="orthographicFront"/>
            <a:lightRig rig="threePt" dir="t"/>
          </a:scene3d>
          <a:sp3d>
            <a:bevelT/>
          </a:sp3d>
        </p:spPr>
        <p:txBody>
          <a:bodyPr wrap="square">
            <a:spAutoFit/>
          </a:bodyPr>
          <a:lstStyle/>
          <a:p>
            <a:pPr defTabSz="1448044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742" b="1" dirty="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rdiovascular diseases</a:t>
            </a:r>
          </a:p>
        </p:txBody>
      </p:sp>
      <p:pic>
        <p:nvPicPr>
          <p:cNvPr id="2062" name="Picture 14" descr="Why Regular Check-Ups Are Crucial For Preventing Cardiovascular Diseases -  Dr. Helena Taylor Clinic">
            <a:extLst>
              <a:ext uri="{FF2B5EF4-FFF2-40B4-BE49-F238E27FC236}">
                <a16:creationId xmlns:a16="http://schemas.microsoft.com/office/drawing/2014/main" id="{EDE7653A-CB7B-FA61-1C1B-F861F693D2C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7634" y="563296"/>
            <a:ext cx="2849252" cy="18995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4FF0831-65BD-37FE-71CF-1806933931A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43" t="5208" r="16850" b="3389"/>
          <a:stretch>
            <a:fillRect/>
          </a:stretch>
        </p:blipFill>
        <p:spPr bwMode="auto">
          <a:xfrm>
            <a:off x="5661072" y="4607010"/>
            <a:ext cx="2089462" cy="1830157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30D602C-94D0-70F5-3CFD-54DFDC716B4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82" t="588" r="20513" b="4038"/>
          <a:stretch>
            <a:fillRect/>
          </a:stretch>
        </p:blipFill>
        <p:spPr bwMode="auto">
          <a:xfrm>
            <a:off x="7559688" y="4510076"/>
            <a:ext cx="1474243" cy="193788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802AEE6-BFA9-AE17-98C4-DB156F69D0AF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5202" t="5437" r="8272" b="5294"/>
          <a:stretch>
            <a:fillRect/>
          </a:stretch>
        </p:blipFill>
        <p:spPr>
          <a:xfrm>
            <a:off x="9690288" y="4840566"/>
            <a:ext cx="2501712" cy="1607494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5" name="Group 14">
            <a:extLst>
              <a:ext uri="{FF2B5EF4-FFF2-40B4-BE49-F238E27FC236}">
                <a16:creationId xmlns:a16="http://schemas.microsoft.com/office/drawing/2014/main" id="{63A31F07-64C3-6870-D9F2-EBC09638FBDA}"/>
              </a:ext>
            </a:extLst>
          </p:cNvPr>
          <p:cNvGrpSpPr/>
          <p:nvPr/>
        </p:nvGrpSpPr>
        <p:grpSpPr>
          <a:xfrm>
            <a:off x="9052046" y="617441"/>
            <a:ext cx="3057925" cy="1607494"/>
            <a:chOff x="4980929" y="577985"/>
            <a:chExt cx="3057925" cy="1607494"/>
          </a:xfrm>
        </p:grpSpPr>
        <p:pic>
          <p:nvPicPr>
            <p:cNvPr id="3082" name="Picture 10" descr="AI-Driven HPLC method development with ChromSwordAuto® software.">
              <a:extLst>
                <a:ext uri="{FF2B5EF4-FFF2-40B4-BE49-F238E27FC236}">
                  <a16:creationId xmlns:a16="http://schemas.microsoft.com/office/drawing/2014/main" id="{CF935998-708A-1EE0-6530-29CD9CD376D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81087" y="577985"/>
              <a:ext cx="2857767" cy="160749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TextBox 30">
              <a:extLst>
                <a:ext uri="{FF2B5EF4-FFF2-40B4-BE49-F238E27FC236}">
                  <a16:creationId xmlns:a16="http://schemas.microsoft.com/office/drawing/2014/main" id="{31FC2C43-6EB0-B751-F262-80AEAFE388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80929" y="987092"/>
              <a:ext cx="1649850" cy="523220"/>
            </a:xfrm>
            <a:prstGeom prst="rect">
              <a:avLst/>
            </a:prstGeom>
            <a:noFill/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/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algn="ctr" defTabSz="1448044" fontAlgn="base">
                <a:spcBef>
                  <a:spcPct val="0"/>
                </a:spcBef>
                <a:spcAft>
                  <a:spcPct val="0"/>
                </a:spcAft>
                <a:buNone/>
                <a:defRPr/>
              </a:pPr>
              <a:r>
                <a:rPr lang="en-US" alt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I-Driven HPLC developer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3A256D23-C6D9-61DB-EAAD-69DC5CC2204C}"/>
              </a:ext>
            </a:extLst>
          </p:cNvPr>
          <p:cNvGrpSpPr/>
          <p:nvPr/>
        </p:nvGrpSpPr>
        <p:grpSpPr>
          <a:xfrm>
            <a:off x="4819341" y="162029"/>
            <a:ext cx="2516106" cy="2027114"/>
            <a:chOff x="6236063" y="2444452"/>
            <a:chExt cx="2407562" cy="2201751"/>
          </a:xfrm>
        </p:grpSpPr>
        <p:pic>
          <p:nvPicPr>
            <p:cNvPr id="12" name="Image 13" descr="preencoded.png">
              <a:extLst>
                <a:ext uri="{FF2B5EF4-FFF2-40B4-BE49-F238E27FC236}">
                  <a16:creationId xmlns:a16="http://schemas.microsoft.com/office/drawing/2014/main" id="{1E4F6845-B175-8610-C054-E978AF8B351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568016" y="2444452"/>
              <a:ext cx="2075609" cy="2201751"/>
            </a:xfrm>
            <a:prstGeom prst="rect">
              <a:avLst/>
            </a:prstGeom>
          </p:spPr>
        </p:pic>
        <p:sp>
          <p:nvSpPr>
            <p:cNvPr id="2" name="TextBox 28">
              <a:extLst>
                <a:ext uri="{FF2B5EF4-FFF2-40B4-BE49-F238E27FC236}">
                  <a16:creationId xmlns:a16="http://schemas.microsoft.com/office/drawing/2014/main" id="{20AC307C-E71B-B413-D60A-5FE10F1CB7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6063" y="2994747"/>
              <a:ext cx="1352608" cy="334292"/>
            </a:xfrm>
            <a:prstGeom prst="rect">
              <a:avLst/>
            </a:prstGeom>
            <a:noFill/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defTabSz="1448044" fontAlgn="base">
                <a:spcBef>
                  <a:spcPct val="0"/>
                </a:spcBef>
                <a:spcAft>
                  <a:spcPct val="0"/>
                </a:spcAft>
                <a:buNone/>
                <a:defRPr/>
              </a:pPr>
              <a:r>
                <a:rPr lang="en-US" alt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PLC Analysis</a:t>
              </a:r>
            </a:p>
          </p:txBody>
        </p:sp>
      </p:grpSp>
      <p:pic>
        <p:nvPicPr>
          <p:cNvPr id="13360" name="Picture 7">
            <a:extLst>
              <a:ext uri="{FF2B5EF4-FFF2-40B4-BE49-F238E27FC236}">
                <a16:creationId xmlns:a16="http://schemas.microsoft.com/office/drawing/2014/main" id="{9667891A-6019-858D-2531-FB985906531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9690288" y="4029472"/>
            <a:ext cx="762807" cy="5548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id="{34EF5D83-C10F-409D-EACE-F63904839A31}"/>
              </a:ext>
            </a:extLst>
          </p:cNvPr>
          <p:cNvGrpSpPr/>
          <p:nvPr/>
        </p:nvGrpSpPr>
        <p:grpSpPr>
          <a:xfrm rot="888200">
            <a:off x="9148025" y="4021050"/>
            <a:ext cx="436123" cy="551854"/>
            <a:chOff x="4830234" y="1257302"/>
            <a:chExt cx="436123" cy="551854"/>
          </a:xfrm>
          <a:solidFill>
            <a:schemeClr val="tx2">
              <a:lumMod val="50000"/>
            </a:schemeClr>
          </a:solidFill>
        </p:grpSpPr>
        <p:sp>
          <p:nvSpPr>
            <p:cNvPr id="23" name="Arrow: Right 22">
              <a:extLst>
                <a:ext uri="{FF2B5EF4-FFF2-40B4-BE49-F238E27FC236}">
                  <a16:creationId xmlns:a16="http://schemas.microsoft.com/office/drawing/2014/main" id="{6A2D334E-14FE-C691-B51E-D6E225D40417}"/>
                </a:ext>
              </a:extLst>
            </p:cNvPr>
            <p:cNvSpPr/>
            <p:nvPr/>
          </p:nvSpPr>
          <p:spPr>
            <a:xfrm rot="2160000">
              <a:off x="4830234" y="1257302"/>
              <a:ext cx="436123" cy="551854"/>
            </a:xfrm>
            <a:prstGeom prst="rightArrow">
              <a:avLst>
                <a:gd name="adj1" fmla="val 60000"/>
                <a:gd name="adj2" fmla="val 50000"/>
              </a:avLst>
            </a:prstGeom>
            <a:grpFill/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4">
                <a:hueOff val="0"/>
                <a:satOff val="0"/>
                <a:lumOff val="0"/>
                <a:alphaOff val="0"/>
              </a:schemeClr>
            </a:fillRef>
            <a:effectRef idx="0">
              <a:schemeClr val="accent4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26" name="Arrow: Right 4">
              <a:extLst>
                <a:ext uri="{FF2B5EF4-FFF2-40B4-BE49-F238E27FC236}">
                  <a16:creationId xmlns:a16="http://schemas.microsoft.com/office/drawing/2014/main" id="{4C137687-A9B2-1147-3E2E-709EC9340068}"/>
                </a:ext>
              </a:extLst>
            </p:cNvPr>
            <p:cNvSpPr txBox="1"/>
            <p:nvPr/>
          </p:nvSpPr>
          <p:spPr>
            <a:xfrm rot="2160000">
              <a:off x="4842728" y="1329221"/>
              <a:ext cx="305286" cy="331112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10223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US" sz="2300" kern="1200"/>
            </a:p>
          </p:txBody>
        </p:sp>
      </p:grpSp>
      <p:pic>
        <p:nvPicPr>
          <p:cNvPr id="35" name="Picture 34">
            <a:extLst>
              <a:ext uri="{FF2B5EF4-FFF2-40B4-BE49-F238E27FC236}">
                <a16:creationId xmlns:a16="http://schemas.microsoft.com/office/drawing/2014/main" id="{B6565AA9-5FDB-07FE-BB7F-E6032A02F819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1985" t="3936" r="11797" b="3205"/>
          <a:stretch>
            <a:fillRect/>
          </a:stretch>
        </p:blipFill>
        <p:spPr>
          <a:xfrm>
            <a:off x="7375761" y="2189143"/>
            <a:ext cx="2446147" cy="1726645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6" name="Group 35">
            <a:extLst>
              <a:ext uri="{FF2B5EF4-FFF2-40B4-BE49-F238E27FC236}">
                <a16:creationId xmlns:a16="http://schemas.microsoft.com/office/drawing/2014/main" id="{C5CC1919-E5EF-BE98-9C59-B6A9EC315A49}"/>
              </a:ext>
            </a:extLst>
          </p:cNvPr>
          <p:cNvGrpSpPr/>
          <p:nvPr/>
        </p:nvGrpSpPr>
        <p:grpSpPr>
          <a:xfrm>
            <a:off x="7454392" y="4062187"/>
            <a:ext cx="551854" cy="436123"/>
            <a:chOff x="5400669" y="3201920"/>
            <a:chExt cx="551854" cy="436123"/>
          </a:xfrm>
          <a:solidFill>
            <a:schemeClr val="tx2">
              <a:lumMod val="50000"/>
            </a:schemeClr>
          </a:solidFill>
        </p:grpSpPr>
        <p:sp>
          <p:nvSpPr>
            <p:cNvPr id="37" name="Arrow: Right 36">
              <a:extLst>
                <a:ext uri="{FF2B5EF4-FFF2-40B4-BE49-F238E27FC236}">
                  <a16:creationId xmlns:a16="http://schemas.microsoft.com/office/drawing/2014/main" id="{80B09CD8-14C4-000D-57FD-CFF3400023E2}"/>
                </a:ext>
              </a:extLst>
            </p:cNvPr>
            <p:cNvSpPr/>
            <p:nvPr/>
          </p:nvSpPr>
          <p:spPr>
            <a:xfrm rot="6480000">
              <a:off x="5458534" y="3144055"/>
              <a:ext cx="436123" cy="551854"/>
            </a:xfrm>
            <a:prstGeom prst="rightArrow">
              <a:avLst>
                <a:gd name="adj1" fmla="val 60000"/>
                <a:gd name="adj2" fmla="val 50000"/>
              </a:avLst>
            </a:prstGeom>
            <a:grpFill/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4">
                <a:hueOff val="-1116192"/>
                <a:satOff val="6725"/>
                <a:lumOff val="539"/>
                <a:alphaOff val="0"/>
              </a:schemeClr>
            </a:fillRef>
            <a:effectRef idx="0">
              <a:schemeClr val="accent4">
                <a:hueOff val="-1116192"/>
                <a:satOff val="6725"/>
                <a:lumOff val="539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38" name="Arrow: Right 4">
              <a:extLst>
                <a:ext uri="{FF2B5EF4-FFF2-40B4-BE49-F238E27FC236}">
                  <a16:creationId xmlns:a16="http://schemas.microsoft.com/office/drawing/2014/main" id="{E5C73072-ADC1-F96F-9E05-727D333392A5}"/>
                </a:ext>
              </a:extLst>
            </p:cNvPr>
            <p:cNvSpPr txBox="1"/>
            <p:nvPr/>
          </p:nvSpPr>
          <p:spPr>
            <a:xfrm rot="17280000">
              <a:off x="5544168" y="3192209"/>
              <a:ext cx="305286" cy="331112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10223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US" sz="2300" kern="1200"/>
            </a:p>
          </p:txBody>
        </p: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D6366D02-9E41-A51E-A917-C84A707B61FB}"/>
              </a:ext>
            </a:extLst>
          </p:cNvPr>
          <p:cNvSpPr txBox="1"/>
          <p:nvPr/>
        </p:nvSpPr>
        <p:spPr>
          <a:xfrm>
            <a:off x="5824635" y="6447965"/>
            <a:ext cx="3289867" cy="338554"/>
          </a:xfrm>
          <a:prstGeom prst="rect">
            <a:avLst/>
          </a:prstGeom>
          <a:noFill/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/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wrap="square">
            <a:spAutoFit/>
          </a:bodyPr>
          <a:lstStyle>
            <a:defPPr>
              <a:defRPr lang="en-US"/>
            </a:defPPr>
            <a:lvl1pPr algn="ctr" defTabSz="1448044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None/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dirty="0"/>
              <a:t>Multi-Color Assessment (MA) Tool </a:t>
            </a:r>
          </a:p>
        </p:txBody>
      </p:sp>
      <p:sp>
        <p:nvSpPr>
          <p:cNvPr id="9" name="Arrow: Left-Right 8">
            <a:extLst>
              <a:ext uri="{FF2B5EF4-FFF2-40B4-BE49-F238E27FC236}">
                <a16:creationId xmlns:a16="http://schemas.microsoft.com/office/drawing/2014/main" id="{6D10270C-BBF7-4756-E4D8-A7D80E09F70C}"/>
              </a:ext>
            </a:extLst>
          </p:cNvPr>
          <p:cNvSpPr/>
          <p:nvPr/>
        </p:nvSpPr>
        <p:spPr>
          <a:xfrm>
            <a:off x="7926013" y="1262288"/>
            <a:ext cx="1280160" cy="473415"/>
          </a:xfrm>
          <a:prstGeom prst="leftRightArrow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26" name="Picture 2" descr="Eppendorf (opened) | Free SVG">
            <a:extLst>
              <a:ext uri="{FF2B5EF4-FFF2-40B4-BE49-F238E27FC236}">
                <a16:creationId xmlns:a16="http://schemas.microsoft.com/office/drawing/2014/main" id="{330239BD-2D7C-0F3E-55BB-0CBC5BB0833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37182" y="3330008"/>
            <a:ext cx="691692" cy="6916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CF605603-50C4-01AC-4F00-38BEDC1B155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8" t="29004" r="7538" b="7824"/>
          <a:stretch>
            <a:fillRect/>
          </a:stretch>
        </p:blipFill>
        <p:spPr bwMode="auto">
          <a:xfrm>
            <a:off x="10767637" y="4006178"/>
            <a:ext cx="630782" cy="6319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768C538E-6FFA-D712-0035-48082FA28784}"/>
              </a:ext>
            </a:extLst>
          </p:cNvPr>
          <p:cNvSpPr txBox="1"/>
          <p:nvPr/>
        </p:nvSpPr>
        <p:spPr>
          <a:xfrm>
            <a:off x="2407889" y="2509756"/>
            <a:ext cx="1166606" cy="307777"/>
          </a:xfrm>
          <a:prstGeom prst="rect">
            <a:avLst/>
          </a:prstGeom>
          <a:solidFill>
            <a:srgbClr val="C00000"/>
          </a:solidFill>
          <a:scene3d>
            <a:camera prst="orthographicFront"/>
            <a:lightRig rig="threePt" dir="t"/>
          </a:scene3d>
          <a:sp3d>
            <a:bevelT/>
          </a:sp3d>
        </p:spPr>
        <p:txBody>
          <a:bodyPr wrap="square">
            <a:spAutoFit/>
          </a:bodyPr>
          <a:lstStyle/>
          <a:p>
            <a:pPr defTabSz="1448044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400" b="1" dirty="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-Therapy</a:t>
            </a:r>
          </a:p>
        </p:txBody>
      </p:sp>
      <p:sp>
        <p:nvSpPr>
          <p:cNvPr id="32" name="TextBox 5">
            <a:extLst>
              <a:ext uri="{FF2B5EF4-FFF2-40B4-BE49-F238E27FC236}">
                <a16:creationId xmlns:a16="http://schemas.microsoft.com/office/drawing/2014/main" id="{F7B11E23-1EDD-1B6A-8EB3-182DA03F43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62000" y="6149844"/>
            <a:ext cx="1253249" cy="4823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algn="ctr" defTabSz="1448044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lodipine (AMD)</a:t>
            </a:r>
          </a:p>
        </p:txBody>
      </p:sp>
      <p:sp>
        <p:nvSpPr>
          <p:cNvPr id="33" name="TextBox 6">
            <a:extLst>
              <a:ext uri="{FF2B5EF4-FFF2-40B4-BE49-F238E27FC236}">
                <a16:creationId xmlns:a16="http://schemas.microsoft.com/office/drawing/2014/main" id="{DCFB7128-8EA3-BF9E-6F62-E246D36C15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9068" y="6127209"/>
            <a:ext cx="875598" cy="4823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algn="ctr" defTabSz="1448044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ltiazem (DTZ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3939014-D069-7420-5BE7-E9EF47CED8A1}"/>
              </a:ext>
            </a:extLst>
          </p:cNvPr>
          <p:cNvSpPr txBox="1"/>
          <p:nvPr/>
        </p:nvSpPr>
        <p:spPr bwMode="auto">
          <a:xfrm>
            <a:off x="2349228" y="4472732"/>
            <a:ext cx="1216742" cy="482312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>
            <a:spAutoFit/>
          </a:bodyPr>
          <a:lstStyle/>
          <a:p>
            <a:pPr algn="ctr" defTabSz="1448044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267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nolazine (RNZ)</a:t>
            </a:r>
          </a:p>
        </p:txBody>
      </p:sp>
      <p:pic>
        <p:nvPicPr>
          <p:cNvPr id="39" name="Graphic 38" descr="Add">
            <a:extLst>
              <a:ext uri="{FF2B5EF4-FFF2-40B4-BE49-F238E27FC236}">
                <a16:creationId xmlns:a16="http://schemas.microsoft.com/office/drawing/2014/main" id="{48C90D5D-02BF-2874-1907-9D4455EEDC18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3715091" y="4235982"/>
            <a:ext cx="410995" cy="410995"/>
          </a:xfrm>
          <a:prstGeom prst="rect">
            <a:avLst/>
          </a:prstGeom>
        </p:spPr>
      </p:pic>
      <p:pic>
        <p:nvPicPr>
          <p:cNvPr id="40" name="Graphic 39" descr="Add">
            <a:extLst>
              <a:ext uri="{FF2B5EF4-FFF2-40B4-BE49-F238E27FC236}">
                <a16:creationId xmlns:a16="http://schemas.microsoft.com/office/drawing/2014/main" id="{2068F276-4F35-9BBE-13A7-16E5F9B56DA0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1796787" y="4227085"/>
            <a:ext cx="410995" cy="410995"/>
          </a:xfrm>
          <a:prstGeom prst="rect">
            <a:avLst/>
          </a:prstGeom>
        </p:spPr>
      </p:pic>
      <p:pic>
        <p:nvPicPr>
          <p:cNvPr id="41" name="Picture 8" descr="DELAY-TIAZEM SR 90 MG ( DILTIAZEM ) 10 CAPSULES">
            <a:extLst>
              <a:ext uri="{FF2B5EF4-FFF2-40B4-BE49-F238E27FC236}">
                <a16:creationId xmlns:a16="http://schemas.microsoft.com/office/drawing/2014/main" id="{A4A63FFA-9E42-D65B-4E99-AB0779BAA3F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0" t="14149" r="6682" b="17958"/>
          <a:stretch>
            <a:fillRect/>
          </a:stretch>
        </p:blipFill>
        <p:spPr bwMode="auto">
          <a:xfrm>
            <a:off x="615935" y="4853543"/>
            <a:ext cx="1371460" cy="1038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2" descr="Norvasc 10 mg - 15 Tablets | Bloom Pharmacy">
            <a:extLst>
              <a:ext uri="{FF2B5EF4-FFF2-40B4-BE49-F238E27FC236}">
                <a16:creationId xmlns:a16="http://schemas.microsoft.com/office/drawing/2014/main" id="{F30E6C8F-2429-06FC-52F1-EEB446F42CA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20" t="29825" r="6788" b="30294"/>
          <a:stretch>
            <a:fillRect/>
          </a:stretch>
        </p:blipFill>
        <p:spPr bwMode="auto">
          <a:xfrm>
            <a:off x="3616656" y="5021722"/>
            <a:ext cx="1943935" cy="8932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2CEE9298-FD34-155D-06B8-63AFB092F125}"/>
              </a:ext>
            </a:extLst>
          </p:cNvPr>
          <p:cNvPicPr>
            <a:picLocks noChangeAspect="1"/>
          </p:cNvPicPr>
          <p:nvPr/>
        </p:nvPicPr>
        <p:blipFill>
          <a:blip r:embed="rId16"/>
          <a:srcRect l="11099" t="19106" r="10313" b="16681"/>
          <a:stretch>
            <a:fillRect/>
          </a:stretch>
        </p:blipFill>
        <p:spPr>
          <a:xfrm>
            <a:off x="2259688" y="3239851"/>
            <a:ext cx="1486215" cy="1214362"/>
          </a:xfrm>
          <a:prstGeom prst="rect">
            <a:avLst/>
          </a:prstGeom>
        </p:spPr>
      </p:pic>
      <p:grpSp>
        <p:nvGrpSpPr>
          <p:cNvPr id="44" name="Group 43">
            <a:extLst>
              <a:ext uri="{FF2B5EF4-FFF2-40B4-BE49-F238E27FC236}">
                <a16:creationId xmlns:a16="http://schemas.microsoft.com/office/drawing/2014/main" id="{09086F31-47DD-9DF5-AC3B-0DB7866EB1AA}"/>
              </a:ext>
            </a:extLst>
          </p:cNvPr>
          <p:cNvGrpSpPr/>
          <p:nvPr/>
        </p:nvGrpSpPr>
        <p:grpSpPr>
          <a:xfrm rot="16200000">
            <a:off x="2749974" y="2801880"/>
            <a:ext cx="436123" cy="551854"/>
            <a:chOff x="3858281" y="4324642"/>
            <a:chExt cx="436123" cy="551854"/>
          </a:xfrm>
          <a:solidFill>
            <a:schemeClr val="tx2">
              <a:lumMod val="50000"/>
            </a:schemeClr>
          </a:solidFill>
        </p:grpSpPr>
        <p:sp>
          <p:nvSpPr>
            <p:cNvPr id="46" name="Arrow: Right 45">
              <a:extLst>
                <a:ext uri="{FF2B5EF4-FFF2-40B4-BE49-F238E27FC236}">
                  <a16:creationId xmlns:a16="http://schemas.microsoft.com/office/drawing/2014/main" id="{983ED001-A6AA-A88D-A948-60821DDCC93E}"/>
                </a:ext>
              </a:extLst>
            </p:cNvPr>
            <p:cNvSpPr/>
            <p:nvPr/>
          </p:nvSpPr>
          <p:spPr>
            <a:xfrm rot="10800000">
              <a:off x="3858281" y="4324642"/>
              <a:ext cx="436123" cy="551854"/>
            </a:xfrm>
            <a:prstGeom prst="rightArrow">
              <a:avLst>
                <a:gd name="adj1" fmla="val 60000"/>
                <a:gd name="adj2" fmla="val 50000"/>
              </a:avLst>
            </a:prstGeom>
            <a:grpFill/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4">
                <a:hueOff val="-2232385"/>
                <a:satOff val="13449"/>
                <a:lumOff val="1078"/>
                <a:alphaOff val="0"/>
              </a:schemeClr>
            </a:fillRef>
            <a:effectRef idx="0">
              <a:schemeClr val="accent4">
                <a:hueOff val="-2232385"/>
                <a:satOff val="13449"/>
                <a:lumOff val="1078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47" name="Arrow: Right 4">
              <a:extLst>
                <a:ext uri="{FF2B5EF4-FFF2-40B4-BE49-F238E27FC236}">
                  <a16:creationId xmlns:a16="http://schemas.microsoft.com/office/drawing/2014/main" id="{38198DD9-8F42-3D4B-99AA-1ABC4FDB344C}"/>
                </a:ext>
              </a:extLst>
            </p:cNvPr>
            <p:cNvSpPr txBox="1"/>
            <p:nvPr/>
          </p:nvSpPr>
          <p:spPr>
            <a:xfrm rot="21600000">
              <a:off x="3989118" y="4435013"/>
              <a:ext cx="305286" cy="331112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0" tIns="0" rIns="0" bIns="0" numCol="1" spcCol="1270" anchor="ctr" anchorCtr="0">
              <a:noAutofit/>
            </a:bodyPr>
            <a:lstStyle/>
            <a:p>
              <a:pPr marL="0" lvl="0" indent="0" algn="ctr" defTabSz="10223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US" sz="2300" kern="1200"/>
            </a:p>
          </p:txBody>
        </p:sp>
      </p:grpSp>
      <p:sp>
        <p:nvSpPr>
          <p:cNvPr id="10" name="Isosceles Triangle 9">
            <a:extLst>
              <a:ext uri="{FF2B5EF4-FFF2-40B4-BE49-F238E27FC236}">
                <a16:creationId xmlns:a16="http://schemas.microsoft.com/office/drawing/2014/main" id="{5347AC14-2FF4-E7F0-54EF-87C383E2D545}"/>
              </a:ext>
            </a:extLst>
          </p:cNvPr>
          <p:cNvSpPr/>
          <p:nvPr/>
        </p:nvSpPr>
        <p:spPr>
          <a:xfrm>
            <a:off x="5857293" y="2127520"/>
            <a:ext cx="1101898" cy="924945"/>
          </a:xfrm>
          <a:prstGeom prst="triangle">
            <a:avLst/>
          </a:prstGeom>
          <a:solidFill>
            <a:srgbClr val="8EEB89"/>
          </a:solidFill>
          <a:ln>
            <a:solidFill>
              <a:srgbClr val="8EEB89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QS</a:t>
            </a:r>
          </a:p>
          <a:p>
            <a:pPr algn="ctr"/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11" name="Isosceles Triangle 10">
            <a:extLst>
              <a:ext uri="{FF2B5EF4-FFF2-40B4-BE49-F238E27FC236}">
                <a16:creationId xmlns:a16="http://schemas.microsoft.com/office/drawing/2014/main" id="{9815DE2E-B17B-5B50-24F6-AFA6EFF7FB02}"/>
              </a:ext>
            </a:extLst>
          </p:cNvPr>
          <p:cNvSpPr/>
          <p:nvPr/>
        </p:nvSpPr>
        <p:spPr>
          <a:xfrm>
            <a:off x="10439964" y="2113376"/>
            <a:ext cx="1143054" cy="939089"/>
          </a:xfrm>
          <a:prstGeom prst="triangle">
            <a:avLst/>
          </a:prstGeom>
          <a:solidFill>
            <a:schemeClr val="accent6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QS</a:t>
            </a:r>
          </a:p>
          <a:p>
            <a:pPr algn="ctr"/>
            <a:r>
              <a:rPr lang="en-US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0DB92D5C-8A6E-71C8-C062-567908B00DEE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7808602" y="13830"/>
            <a:ext cx="1514982" cy="151498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3E28AFBE-0A60-6F99-59E6-6BF2ED9C6994}"/>
              </a:ext>
            </a:extLst>
          </p:cNvPr>
          <p:cNvSpPr txBox="1"/>
          <p:nvPr/>
        </p:nvSpPr>
        <p:spPr>
          <a:xfrm>
            <a:off x="8238960" y="499318"/>
            <a:ext cx="6989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highlight>
                  <a:srgbClr val="00FF00"/>
                </a:highlight>
              </a:rPr>
              <a:t>SDG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93788F8-3EC6-7211-568A-8D5CD5E04EC0}"/>
              </a:ext>
            </a:extLst>
          </p:cNvPr>
          <p:cNvSpPr txBox="1"/>
          <p:nvPr/>
        </p:nvSpPr>
        <p:spPr>
          <a:xfrm>
            <a:off x="5661072" y="4469204"/>
            <a:ext cx="3453430" cy="20271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79259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7</TotalTime>
  <Words>34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ismail aborass</dc:creator>
  <cp:lastModifiedBy>Sara ismail aborass</cp:lastModifiedBy>
  <cp:revision>4</cp:revision>
  <dcterms:created xsi:type="dcterms:W3CDTF">2025-11-14T19:35:31Z</dcterms:created>
  <dcterms:modified xsi:type="dcterms:W3CDTF">2026-01-06T20:17:37Z</dcterms:modified>
</cp:coreProperties>
</file>